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5A6DD-03D1-4901-BE78-487DB0B351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5614B-ED5A-4548-BE48-A740FC2881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5D1173-4517-4300-A121-58D0AF4CBC0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04CAE-20C1-44B0-BE24-A9B47643C84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4AD8C-0C35-42F3-8204-A654F1F3A3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A903BD-C566-4529-81AB-1A8DF1DF44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E72C59-00D6-42E3-956C-D717D058DF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1091C7-85D2-4A01-B175-FCD9DB2F91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758D8-3FEE-4945-9133-3475A334684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B673D-B877-4A6B-8400-04F18002B0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2BE215-051B-40B0-B2AE-837F689A952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001C0B-7186-47F5-B0ED-B66ACFCF9A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  <a:ea typeface="宋体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608C0A-AC2C-456E-9B72-D80481881EDD}" type="slidenum">
              <a:rPr b="0" lang="zh-CN" sz="1200" spc="-1" strike="noStrike">
                <a:solidFill>
                  <a:srgbClr val="898989"/>
                </a:solidFill>
                <a:latin typeface="Calibri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0"/>
          <p:cNvSpPr/>
          <p:nvPr/>
        </p:nvSpPr>
        <p:spPr>
          <a:xfrm>
            <a:off x="5760" y="3240"/>
            <a:ext cx="1626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orting Figure S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425880" y="1979640"/>
            <a:ext cx="5994720" cy="2330280"/>
            <a:chOff x="425880" y="1979640"/>
            <a:chExt cx="5994720" cy="2330280"/>
          </a:xfrm>
        </p:grpSpPr>
        <p:sp>
          <p:nvSpPr>
            <p:cNvPr id="43" name="TextBox 19"/>
            <p:cNvSpPr/>
            <p:nvPr/>
          </p:nvSpPr>
          <p:spPr>
            <a:xfrm>
              <a:off x="425880" y="3707640"/>
              <a:ext cx="10296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nbr1-1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/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200" spc="-1" strike="noStrike">
                  <a:solidFill>
                    <a:srgbClr val="000000"/>
                  </a:solidFill>
                  <a:latin typeface="Arial"/>
                </a:rPr>
                <a:t>35S:mNBR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" name="Group 2"/>
            <p:cNvGrpSpPr/>
            <p:nvPr/>
          </p:nvGrpSpPr>
          <p:grpSpPr>
            <a:xfrm>
              <a:off x="569160" y="1979640"/>
              <a:ext cx="5851440" cy="2330280"/>
              <a:chOff x="569160" y="1979640"/>
              <a:chExt cx="5851440" cy="2330280"/>
            </a:xfrm>
          </p:grpSpPr>
          <p:grpSp>
            <p:nvGrpSpPr>
              <p:cNvPr id="45" name="Group 1"/>
              <p:cNvGrpSpPr/>
              <p:nvPr/>
            </p:nvGrpSpPr>
            <p:grpSpPr>
              <a:xfrm>
                <a:off x="1462320" y="3583440"/>
                <a:ext cx="3906360" cy="726480"/>
                <a:chOff x="1462320" y="3583440"/>
                <a:chExt cx="3906360" cy="726480"/>
              </a:xfrm>
            </p:grpSpPr>
            <p:pic>
              <p:nvPicPr>
                <p:cNvPr id="46" name="图片 30" descr="s2-2.jpg"/>
                <p:cNvPicPr/>
                <p:nvPr/>
              </p:nvPicPr>
              <p:blipFill>
                <a:blip r:embed="rId1"/>
                <a:srcRect l="1246" t="0" r="0" b="53864"/>
                <a:stretch/>
              </p:blipFill>
              <p:spPr>
                <a:xfrm>
                  <a:off x="1462320" y="3583440"/>
                  <a:ext cx="3906360" cy="4287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7" name="图片 6" descr="s2-2.jpg"/>
                <p:cNvPicPr/>
                <p:nvPr/>
              </p:nvPicPr>
              <p:blipFill>
                <a:blip r:embed="rId2"/>
                <a:srcRect l="1246" t="61553" r="0" b="7689"/>
                <a:stretch/>
              </p:blipFill>
              <p:spPr>
                <a:xfrm>
                  <a:off x="1462320" y="4024080"/>
                  <a:ext cx="3906360" cy="2858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48" name="TextBox 13"/>
              <p:cNvSpPr/>
              <p:nvPr/>
            </p:nvSpPr>
            <p:spPr>
              <a:xfrm>
                <a:off x="4846680" y="2369880"/>
                <a:ext cx="62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nbr1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直接连接符 14"/>
              <p:cNvSpPr/>
              <p:nvPr/>
            </p:nvSpPr>
            <p:spPr>
              <a:xfrm>
                <a:off x="1442880" y="2301840"/>
                <a:ext cx="3262680" cy="4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2120" bIns="-4212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TextBox 15"/>
              <p:cNvSpPr/>
              <p:nvPr/>
            </p:nvSpPr>
            <p:spPr>
              <a:xfrm>
                <a:off x="2461320" y="1979640"/>
                <a:ext cx="1694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nbr1-1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 transgenic line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TextBox 20"/>
              <p:cNvSpPr/>
              <p:nvPr/>
            </p:nvSpPr>
            <p:spPr>
              <a:xfrm>
                <a:off x="5299920" y="2676240"/>
                <a:ext cx="976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BR1-MY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Box 21"/>
              <p:cNvSpPr/>
              <p:nvPr/>
            </p:nvSpPr>
            <p:spPr>
              <a:xfrm>
                <a:off x="5317920" y="3613680"/>
                <a:ext cx="1102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mNBR1-MY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TextBox 22"/>
              <p:cNvSpPr/>
              <p:nvPr/>
            </p:nvSpPr>
            <p:spPr>
              <a:xfrm>
                <a:off x="5290200" y="3068280"/>
                <a:ext cx="732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ubisc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TextBox 23"/>
              <p:cNvSpPr/>
              <p:nvPr/>
            </p:nvSpPr>
            <p:spPr>
              <a:xfrm>
                <a:off x="5324760" y="4021200"/>
                <a:ext cx="7322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Rubisco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Box 18"/>
              <p:cNvSpPr/>
              <p:nvPr/>
            </p:nvSpPr>
            <p:spPr>
              <a:xfrm>
                <a:off x="569160" y="2813400"/>
                <a:ext cx="90324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nbr1-1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/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1200" spc="-1" strike="noStrike">
                    <a:solidFill>
                      <a:srgbClr val="000000"/>
                    </a:solidFill>
                    <a:latin typeface="Arial"/>
                  </a:rPr>
                  <a:t>35S:NBR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56" name="Picture 5" descr=""/>
              <p:cNvPicPr/>
              <p:nvPr/>
            </p:nvPicPr>
            <p:blipFill>
              <a:blip r:embed="rId3"/>
              <a:stretch/>
            </p:blipFill>
            <p:spPr>
              <a:xfrm>
                <a:off x="1447200" y="2630160"/>
                <a:ext cx="3911760" cy="431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7" name="Picture 6" descr=""/>
              <p:cNvPicPr/>
              <p:nvPr/>
            </p:nvPicPr>
            <p:blipFill>
              <a:blip r:embed="rId4"/>
              <a:stretch/>
            </p:blipFill>
            <p:spPr>
              <a:xfrm>
                <a:off x="1429920" y="3072240"/>
                <a:ext cx="3924360" cy="29196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TextBox 32"/>
              <p:cNvSpPr/>
              <p:nvPr/>
            </p:nvSpPr>
            <p:spPr>
              <a:xfrm>
                <a:off x="1516320" y="23616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TextBox 33"/>
              <p:cNvSpPr/>
              <p:nvPr/>
            </p:nvSpPr>
            <p:spPr>
              <a:xfrm>
                <a:off x="2032920" y="23529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TextBox 34"/>
              <p:cNvSpPr/>
              <p:nvPr/>
            </p:nvSpPr>
            <p:spPr>
              <a:xfrm>
                <a:off x="2532240" y="23529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3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TextBox 35"/>
              <p:cNvSpPr/>
              <p:nvPr/>
            </p:nvSpPr>
            <p:spPr>
              <a:xfrm>
                <a:off x="3031920" y="236160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TextBox 36"/>
              <p:cNvSpPr/>
              <p:nvPr/>
            </p:nvSpPr>
            <p:spPr>
              <a:xfrm>
                <a:off x="3531600" y="23529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TextBox 37"/>
              <p:cNvSpPr/>
              <p:nvPr/>
            </p:nvSpPr>
            <p:spPr>
              <a:xfrm>
                <a:off x="4030920" y="23529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6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Box 38"/>
              <p:cNvSpPr/>
              <p:nvPr/>
            </p:nvSpPr>
            <p:spPr>
              <a:xfrm>
                <a:off x="4488480" y="2352960"/>
                <a:ext cx="2660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10T02:00:27Z</dcterms:created>
  <dc:creator>User</dc:creator>
  <dc:description/>
  <dc:language>en-US</dc:language>
  <cp:lastModifiedBy>btnyadmin</cp:lastModifiedBy>
  <dcterms:modified xsi:type="dcterms:W3CDTF">2012-09-24T20:08:31Z</dcterms:modified>
  <cp:revision>17</cp:revision>
  <dc:subject/>
  <dc:title>幻灯片 1</dc:title>
</cp:coreProperties>
</file>